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76"/>
    <p:restoredTop sz="94683"/>
  </p:normalViewPr>
  <p:slideViewPr>
    <p:cSldViewPr snapToGrid="0" snapToObjects="1">
      <p:cViewPr varScale="1">
        <p:scale>
          <a:sx n="102" d="100"/>
          <a:sy n="102" d="100"/>
        </p:scale>
        <p:origin x="7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atashatahmasebi/Documents/LC%20/LCV%20Study/FINALISED%20LCV%20Results%2017.04.21%20V15%20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GB"/>
              <a:t>Percentage symptom burden before and after H1/H2 Antihistamines in 25 patient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AH Data'!$N$34</c:f>
              <c:strCache>
                <c:ptCount val="1"/>
                <c:pt idx="0">
                  <c:v>Before Antihistamin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AH Data'!$O$33:$Y$33</c:f>
              <c:strCache>
                <c:ptCount val="11"/>
                <c:pt idx="0">
                  <c:v>Fatigue </c:v>
                </c:pt>
                <c:pt idx="1">
                  <c:v>Constitutional (sweating, fever, joint/muscle pain)</c:v>
                </c:pt>
                <c:pt idx="2">
                  <c:v>Breathlessness</c:v>
                </c:pt>
                <c:pt idx="3">
                  <c:v>PEM</c:v>
                </c:pt>
                <c:pt idx="4">
                  <c:v>Chest pain </c:v>
                </c:pt>
                <c:pt idx="5">
                  <c:v>Neurology and neurosensory</c:v>
                </c:pt>
                <c:pt idx="6">
                  <c:v>Neuropsychiatry (insomnia, anxiety)</c:v>
                </c:pt>
                <c:pt idx="7">
                  <c:v>Dysautonomia</c:v>
                </c:pt>
                <c:pt idx="8">
                  <c:v>ENT</c:v>
                </c:pt>
                <c:pt idx="9">
                  <c:v>GI</c:v>
                </c:pt>
                <c:pt idx="10">
                  <c:v>Dermatology</c:v>
                </c:pt>
              </c:strCache>
            </c:strRef>
          </c:cat>
          <c:val>
            <c:numRef>
              <c:f>'AH Data'!$O$34:$Y$34</c:f>
              <c:numCache>
                <c:formatCode>0.0</c:formatCode>
                <c:ptCount val="11"/>
                <c:pt idx="0">
                  <c:v>64</c:v>
                </c:pt>
                <c:pt idx="1">
                  <c:v>40</c:v>
                </c:pt>
                <c:pt idx="2">
                  <c:v>20</c:v>
                </c:pt>
                <c:pt idx="3">
                  <c:v>48</c:v>
                </c:pt>
                <c:pt idx="4">
                  <c:v>52</c:v>
                </c:pt>
                <c:pt idx="5">
                  <c:v>52</c:v>
                </c:pt>
                <c:pt idx="6">
                  <c:v>28</c:v>
                </c:pt>
                <c:pt idx="7">
                  <c:v>16</c:v>
                </c:pt>
                <c:pt idx="8">
                  <c:v>40</c:v>
                </c:pt>
                <c:pt idx="9">
                  <c:v>32</c:v>
                </c:pt>
                <c:pt idx="10">
                  <c:v>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F9-744D-8F1F-4F765D5A15FF}"/>
            </c:ext>
          </c:extLst>
        </c:ser>
        <c:ser>
          <c:idx val="1"/>
          <c:order val="1"/>
          <c:tx>
            <c:strRef>
              <c:f>'AH Data'!$N$35</c:f>
              <c:strCache>
                <c:ptCount val="1"/>
                <c:pt idx="0">
                  <c:v>After Antihistamin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AH Data'!$O$33:$Y$33</c:f>
              <c:strCache>
                <c:ptCount val="11"/>
                <c:pt idx="0">
                  <c:v>Fatigue </c:v>
                </c:pt>
                <c:pt idx="1">
                  <c:v>Constitutional (sweating, fever, joint/muscle pain)</c:v>
                </c:pt>
                <c:pt idx="2">
                  <c:v>Breathlessness</c:v>
                </c:pt>
                <c:pt idx="3">
                  <c:v>PEM</c:v>
                </c:pt>
                <c:pt idx="4">
                  <c:v>Chest pain </c:v>
                </c:pt>
                <c:pt idx="5">
                  <c:v>Neurology and neurosensory</c:v>
                </c:pt>
                <c:pt idx="6">
                  <c:v>Neuropsychiatry (insomnia, anxiety)</c:v>
                </c:pt>
                <c:pt idx="7">
                  <c:v>Dysautonomia</c:v>
                </c:pt>
                <c:pt idx="8">
                  <c:v>ENT</c:v>
                </c:pt>
                <c:pt idx="9">
                  <c:v>GI</c:v>
                </c:pt>
                <c:pt idx="10">
                  <c:v>Dermatology</c:v>
                </c:pt>
              </c:strCache>
            </c:strRef>
          </c:cat>
          <c:val>
            <c:numRef>
              <c:f>'AH Data'!$O$35:$Y$35</c:f>
              <c:numCache>
                <c:formatCode>0.0</c:formatCode>
                <c:ptCount val="11"/>
                <c:pt idx="0">
                  <c:v>44</c:v>
                </c:pt>
                <c:pt idx="1">
                  <c:v>28</c:v>
                </c:pt>
                <c:pt idx="2">
                  <c:v>16</c:v>
                </c:pt>
                <c:pt idx="3">
                  <c:v>44</c:v>
                </c:pt>
                <c:pt idx="4">
                  <c:v>24</c:v>
                </c:pt>
                <c:pt idx="5">
                  <c:v>16</c:v>
                </c:pt>
                <c:pt idx="6">
                  <c:v>16</c:v>
                </c:pt>
                <c:pt idx="7">
                  <c:v>16</c:v>
                </c:pt>
                <c:pt idx="8">
                  <c:v>32</c:v>
                </c:pt>
                <c:pt idx="9">
                  <c:v>20</c:v>
                </c:pt>
                <c:pt idx="10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F9-744D-8F1F-4F765D5A15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-2098286008"/>
        <c:axId val="-2098282520"/>
      </c:barChart>
      <c:catAx>
        <c:axId val="-20982860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282520"/>
        <c:crosses val="autoZero"/>
        <c:auto val="1"/>
        <c:lblAlgn val="ctr"/>
        <c:lblOffset val="100"/>
        <c:noMultiLvlLbl val="0"/>
      </c:catAx>
      <c:valAx>
        <c:axId val="-2098282520"/>
        <c:scaling>
          <c:orientation val="minMax"/>
        </c:scaling>
        <c:delete val="0"/>
        <c:axPos val="b"/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98286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512C6-20EF-1D46-9CF9-80B1DA6750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782880-0AC0-BC41-824F-3C3EF1FD79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74859F-7CDF-2643-980F-77BBDFF23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753C66-32A5-294C-8080-9286248B2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DF3818-662F-4441-B2EA-7969F00A6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06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CFA63-39A6-7B4A-8AF3-57625E1ED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76DF31-988F-E447-954A-D10512BF37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6527DE-E6F0-0E46-A532-A7BAB63C5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56F3A6-663A-7647-BA21-E84ACEFDA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31B35-F7DD-B14C-A46D-F0C5AF3CB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690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E93635-9DDB-784A-8FB2-6D4641933E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C8878D-1886-3A42-9EB0-FC4619B380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89729-6524-7941-B285-1BE43EA9E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9E42BD-9FB2-684D-BBBA-95C3845AD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580EE-F677-C743-9BA0-156EB7833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82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413E0-E1EE-0F49-88AF-56C3DA98E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3D2141-AB5B-6848-8D4B-70A031CFB5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8AA4C-D9D9-B942-8AB7-16D3DADA5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DC2E6E-F9A9-1145-AC60-237EC11BB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50393F-49FA-1746-9A68-E8F8051BB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15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270E7-916D-AD45-905B-1B8D487A0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EBB7D3-194E-4847-9878-D3B33D406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75A4-0608-E245-8519-69333537A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E9D5DC-1DE3-744F-9FC4-9A3B5629C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1BD390-B1CE-BA4D-BB7B-D701550BE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45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07E3-3E6C-164B-B9CE-039D3FF67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B1C23D-9D20-9747-9223-4527165929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D8284B-2D5A-8B4C-9906-A23D820B4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C70CA-B061-284F-8267-2E9C25D5D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EAD765-2F80-A84A-B937-E46F12301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6CF04C-1572-3A46-8787-0D528E5F8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904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46C64-20FF-7842-B4E5-DA3131611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E4E339-B7BB-2242-BF8A-FF24E8C48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426AB9-01CF-FB4B-BC22-75B1B625C0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A00B42-F7C0-6D43-9609-83E4C93DC9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5F0EFF-F4C3-3A44-84B0-0AEFB801B0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859AE6-7A96-2340-893E-508ADF52B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3F2D24-5851-F942-8E22-C503F16BB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90E24D-EC6D-494C-B29F-870CD16E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295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D2812-CF4C-A946-A6C5-FBF1ABA41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25B51D-5E36-D841-8A18-27DBAF28D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34BC82-93BF-AC4C-BE58-25E5D77AF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B6414C-8829-C04D-9345-BD5086FCD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3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030F62-BD9F-5942-A15C-A10CDD20C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B52502-235D-FD48-AFD8-8B89BB9A6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9936A4-585C-3440-B6E4-3A40A2216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402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C95306-30B0-034B-88AD-18BB0F59E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C548DA-E7CB-3048-9D8F-883F0B1290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65F38E-39BF-174F-83F8-E69957D5F3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7D2A6A-B251-B44D-93CD-F91AB9B7A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048151-1916-314C-B3A6-EE4F666EF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6F6580-37A3-F54C-AC51-B8C1E5B21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451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97A22-D255-E840-A85D-4E95416799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384AAE-E261-DE4D-A959-F57216CC12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B11EEE-2497-FD44-A629-0DCEC8E13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15BC24-B954-A042-BA48-1BAB40666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688EE6-D0CE-1A48-BEAC-A930D3149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C94DB1-4E2F-2F44-857B-0723BB704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609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F5699F-66D9-C24A-BF03-79A0D706D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F659FE-067B-DC46-86FF-0A62C5AEC4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AD5BE-5DFB-864E-A0F8-AC28A6A1D4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4DC74-F985-B04D-A9DB-9EB011C5CE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3A99FC-4C6A-764C-9DCA-D4491B017F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0B4E345-B905-D540-BF85-F1C861916363}"/>
              </a:ext>
            </a:extLst>
          </p:cNvPr>
          <p:cNvSpPr txBox="1"/>
          <p:nvPr/>
        </p:nvSpPr>
        <p:spPr>
          <a:xfrm>
            <a:off x="600075" y="51435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4F5448E1-17C8-1B4D-9118-C85776AEC43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01617115"/>
              </p:ext>
            </p:extLst>
          </p:nvPr>
        </p:nvGraphicFramePr>
        <p:xfrm>
          <a:off x="2292349" y="1619249"/>
          <a:ext cx="7566026" cy="4253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94016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4</TotalTime>
  <Words>16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ev Gupta</dc:creator>
  <cp:lastModifiedBy>Rajeev Gupta</cp:lastModifiedBy>
  <cp:revision>23</cp:revision>
  <dcterms:created xsi:type="dcterms:W3CDTF">2021-05-16T12:17:13Z</dcterms:created>
  <dcterms:modified xsi:type="dcterms:W3CDTF">2021-06-03T09:11:20Z</dcterms:modified>
</cp:coreProperties>
</file>